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570" y="-30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9957587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27124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9304555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0650723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813905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355431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194259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200404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71354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41229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7929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645451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TextBox 250"/>
          <p:cNvSpPr txBox="1"/>
          <p:nvPr/>
        </p:nvSpPr>
        <p:spPr>
          <a:xfrm>
            <a:off x="402779" y="107504"/>
            <a:ext cx="60486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dirty="0" smtClean="0"/>
              <a:t>Supplemental Figure 2. Stimulation of </a:t>
            </a:r>
            <a:r>
              <a:rPr lang="en-NZ" sz="1200" dirty="0" err="1" smtClean="0"/>
              <a:t>hCMVECs</a:t>
            </a:r>
            <a:r>
              <a:rPr lang="en-NZ" sz="1200" dirty="0" smtClean="0"/>
              <a:t> with the PKC agonist PMA induces similar cytokine response to IL-1</a:t>
            </a:r>
            <a:r>
              <a:rPr lang="el-GR" sz="1200" dirty="0" smtClean="0"/>
              <a:t>β</a:t>
            </a:r>
            <a:r>
              <a:rPr lang="en-NZ" sz="1200" dirty="0" smtClean="0"/>
              <a:t> and TNF</a:t>
            </a:r>
            <a:r>
              <a:rPr lang="el-GR" sz="1200" dirty="0" smtClean="0"/>
              <a:t>α</a:t>
            </a:r>
            <a:r>
              <a:rPr lang="en-NZ" sz="1200" dirty="0"/>
              <a:t>.</a:t>
            </a:r>
          </a:p>
        </p:txBody>
      </p:sp>
      <p:pic>
        <p:nvPicPr>
          <p:cNvPr id="252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3510" y="2087726"/>
            <a:ext cx="2384828" cy="16029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3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58867" y="3707904"/>
            <a:ext cx="2319130" cy="16160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4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5436" y="5332182"/>
            <a:ext cx="2312561" cy="16160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5" name="Picture 25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0320" y="611563"/>
            <a:ext cx="2417677" cy="16160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6" name="Picture 25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0320" y="2087724"/>
            <a:ext cx="2417677" cy="16160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7" name="Picture 1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3800" y="5332182"/>
            <a:ext cx="2404538" cy="1616082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8" name="Picture 2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2082" y="3761898"/>
            <a:ext cx="2404538" cy="16160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9" name="Picture 3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4706" y="611563"/>
            <a:ext cx="2404538" cy="16160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60" name="Picture 2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640" y="7060443"/>
            <a:ext cx="2194686" cy="14757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61" name="Picture 3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1524" y="7062401"/>
            <a:ext cx="2194686" cy="14757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62" name="Picture 4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9158" y="7056276"/>
            <a:ext cx="2214421" cy="14857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40870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3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University of Aucklan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7</cp:revision>
  <dcterms:created xsi:type="dcterms:W3CDTF">2014-12-21T23:06:00Z</dcterms:created>
  <dcterms:modified xsi:type="dcterms:W3CDTF">2014-12-21T23:10:55Z</dcterms:modified>
</cp:coreProperties>
</file>